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  <p:sldId id="256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>
        <p:scale>
          <a:sx n="150" d="100"/>
          <a:sy n="150" d="100"/>
        </p:scale>
        <p:origin x="-1963" y="-26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7D00DB-1161-338E-35E7-726287DD86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20A9AB3-5527-CC7D-E047-5644BC1D90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94F0955-D8E7-A1A3-3449-4CCEFA1F80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8F35B-95AB-41B2-B3E3-DF5F7EA40D41}" type="datetimeFigureOut">
              <a:rPr lang="zh-CN" altLang="en-US" smtClean="0"/>
              <a:t>2023/12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BDCCA2B-3517-832D-1764-8DC53732F7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065E6D3-6F57-8FB0-2861-F71BE6F86A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48C28-DC7D-40F6-9C71-4AC10768B4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53159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AC4DBFF-EB91-BA15-EC1F-74124991D0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4C7805E-417E-5754-1D3F-049D3AA1C5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EBFDC7C-2E22-B209-33D7-7B41FCDBAE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8F35B-95AB-41B2-B3E3-DF5F7EA40D41}" type="datetimeFigureOut">
              <a:rPr lang="zh-CN" altLang="en-US" smtClean="0"/>
              <a:t>2023/12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33EFFE6-8481-FFA4-13BA-0553593711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45533B4-6C3A-8539-5161-11C341616D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48C28-DC7D-40F6-9C71-4AC10768B4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0227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2F97067-F5BE-8882-1E56-B37F24FE14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6C5A4E4-ACB5-8733-1E07-6E69EA2CD6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8481757-9669-F395-4146-9BD6F5E02D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8F35B-95AB-41B2-B3E3-DF5F7EA40D41}" type="datetimeFigureOut">
              <a:rPr lang="zh-CN" altLang="en-US" smtClean="0"/>
              <a:t>2023/12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B356F59-4049-6AF0-9713-67A2BD92B4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4A2E374-16DC-BD50-90F9-4DE1B5B54F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48C28-DC7D-40F6-9C71-4AC10768B4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83958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165FEA3-0EB4-56D7-4E09-92E0BC2644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C8A3CD2-ED3F-CA99-45C3-E80CE1341B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D023A76-CF0D-53AD-855A-3A05D39BA6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8F35B-95AB-41B2-B3E3-DF5F7EA40D41}" type="datetimeFigureOut">
              <a:rPr lang="zh-CN" altLang="en-US" smtClean="0"/>
              <a:t>2023/12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6C32DAB-5888-D805-F9DC-E5EA93E40F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2AAD454-8188-6F26-7197-599AF6C145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48C28-DC7D-40F6-9C71-4AC10768B4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83592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FE489F-EC1E-EE13-F307-BB390B6587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B6D9812-9641-7C70-CACF-A66A0B1193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E435F84-C4EA-ACF6-9E33-8BC744F301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8F35B-95AB-41B2-B3E3-DF5F7EA40D41}" type="datetimeFigureOut">
              <a:rPr lang="zh-CN" altLang="en-US" smtClean="0"/>
              <a:t>2023/12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B9BDC37-0438-73E1-8290-C07EA6487C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EADBDBD-A6AF-3846-50F4-7D615643A6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48C28-DC7D-40F6-9C71-4AC10768B4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14384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E5FDECC-BE3E-711B-DB77-8E8046308C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408D0D0-756B-5895-2909-84E6175C25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B4178DF-4331-2939-FA28-8C5B591D61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D12BE5E-882B-993F-C1D5-08B71740D4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8F35B-95AB-41B2-B3E3-DF5F7EA40D41}" type="datetimeFigureOut">
              <a:rPr lang="zh-CN" altLang="en-US" smtClean="0"/>
              <a:t>2023/12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05E12E4-51DD-2601-95F7-2D8EEA2D86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68921D5-A437-E4CE-070B-DC07D220A6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48C28-DC7D-40F6-9C71-4AC10768B4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87966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62776A9-0E2E-CFE7-00E7-75E7BE149F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AB9C378-6E32-0E6A-2986-F4088D6151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6DB4252-3380-737E-2634-5877DB7DB5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93FAD2E-0564-A1CA-1E5C-61D4D5EADC3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E68308A-FA9D-9CEB-6647-079C736C00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47049C1-47A0-EED3-94E7-28188A319B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8F35B-95AB-41B2-B3E3-DF5F7EA40D41}" type="datetimeFigureOut">
              <a:rPr lang="zh-CN" altLang="en-US" smtClean="0"/>
              <a:t>2023/12/3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C4CFB8D-3D92-1978-7E64-A3A76B072E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55CDB45-490E-D13B-0DD3-453F7B4EE5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48C28-DC7D-40F6-9C71-4AC10768B4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74829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56C16CE-AF93-13E7-A574-A991400C0B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3995E82-78FB-7822-9132-E616C508F0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8F35B-95AB-41B2-B3E3-DF5F7EA40D41}" type="datetimeFigureOut">
              <a:rPr lang="zh-CN" altLang="en-US" smtClean="0"/>
              <a:t>2023/12/3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E9D88D8-E4EA-215F-622D-DEFB52CAD3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2FF0D9B-1839-4E1F-6762-8271263150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48C28-DC7D-40F6-9C71-4AC10768B4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1054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0710BF4-B6EE-2801-E531-3EC1EC772C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8F35B-95AB-41B2-B3E3-DF5F7EA40D41}" type="datetimeFigureOut">
              <a:rPr lang="zh-CN" altLang="en-US" smtClean="0"/>
              <a:t>2023/12/3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46746A3-D6CB-0217-A7CC-353C1BDDE0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8056720-DD63-1871-B9A9-D39EA8F4C4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48C28-DC7D-40F6-9C71-4AC10768B4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79905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43A0191-E980-A7BA-28C5-2739966027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408BF8A-24EA-F176-CF07-01249DED2B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B83D095-DA96-EB02-CA59-F367952923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FFEE2B3-5415-EA10-8B64-7153038755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8F35B-95AB-41B2-B3E3-DF5F7EA40D41}" type="datetimeFigureOut">
              <a:rPr lang="zh-CN" altLang="en-US" smtClean="0"/>
              <a:t>2023/12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CDA8699-957E-A9D3-7BBD-E1FAC06D8C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91F886F-9B49-D19A-466E-948B7EB33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48C28-DC7D-40F6-9C71-4AC10768B4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4124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929CC2-1E7D-D183-36F9-3988FB8E08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7A6341F-23C9-4AE5-7426-B92EFE1151A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818B2A6-A148-546C-87BB-0C864045BA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DDA91BF-FCE1-96A8-F1EB-76008F6C0D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8F35B-95AB-41B2-B3E3-DF5F7EA40D41}" type="datetimeFigureOut">
              <a:rPr lang="zh-CN" altLang="en-US" smtClean="0"/>
              <a:t>2023/12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EA20155-956A-78BD-8F08-91E4E7FF3C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FC869A5-0308-8377-9187-1F515BD23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48C28-DC7D-40F6-9C71-4AC10768B4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84904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05085AA-FF7E-A625-2031-696BF74AFD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12A478C-2460-3287-9500-C36F623AB4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E9F6DEF-F348-DE83-ED5D-7771AD63285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18F35B-95AB-41B2-B3E3-DF5F7EA40D41}" type="datetimeFigureOut">
              <a:rPr lang="zh-CN" altLang="en-US" smtClean="0"/>
              <a:t>2023/12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2BF20C7-9876-2583-A0A0-DC948FB14D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8687C20-EB81-52A8-EC57-5EC75A3ED3A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748C28-DC7D-40F6-9C71-4AC10768B4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72178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E2A669E3-95C9-5578-021E-0F4654605BB1}"/>
              </a:ext>
            </a:extLst>
          </p:cNvPr>
          <p:cNvPicPr>
            <a:picLocks noChangeAspect="1"/>
          </p:cNvPicPr>
          <p:nvPr/>
        </p:nvPicPr>
        <p:blipFill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2522" y="1089014"/>
            <a:ext cx="5760732" cy="4319025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E27DF765-58EF-380D-3709-FCF3B7D5F2A0}"/>
              </a:ext>
            </a:extLst>
          </p:cNvPr>
          <p:cNvSpPr txBox="1"/>
          <p:nvPr/>
        </p:nvSpPr>
        <p:spPr>
          <a:xfrm>
            <a:off x="5625879" y="1840345"/>
            <a:ext cx="24063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2EEDCEE6-5414-F083-813A-665798B37E5E}"/>
              </a:ext>
            </a:extLst>
          </p:cNvPr>
          <p:cNvSpPr txBox="1"/>
          <p:nvPr/>
        </p:nvSpPr>
        <p:spPr>
          <a:xfrm>
            <a:off x="2788820" y="1840345"/>
            <a:ext cx="24063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5CBD1415-6E88-52F7-6D7F-C0CA555FDEB7}"/>
              </a:ext>
            </a:extLst>
          </p:cNvPr>
          <p:cNvSpPr txBox="1"/>
          <p:nvPr/>
        </p:nvSpPr>
        <p:spPr>
          <a:xfrm>
            <a:off x="2788820" y="4689695"/>
            <a:ext cx="5760732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Figure S1  </a:t>
            </a:r>
            <a:r>
              <a:rPr lang="en-US" altLang="zh-CN" sz="105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Pull-down search for matrine-specific effector proteins.</a:t>
            </a:r>
          </a:p>
          <a:p>
            <a:pPr algn="ctr"/>
            <a:r>
              <a:rPr lang="en-US" altLang="zh-CN" sz="1050" b="1" kern="100" dirty="0">
                <a:latin typeface="Arial" panose="020B0604020202020204" pitchFamily="34" charset="0"/>
                <a:ea typeface="宋体" panose="02010600030101010101" pitchFamily="2" charset="-122"/>
              </a:rPr>
              <a:t>A: </a:t>
            </a:r>
            <a:r>
              <a:rPr lang="en-US" altLang="zh-CN" sz="1050" kern="100" dirty="0">
                <a:latin typeface="Arial" panose="020B0604020202020204" pitchFamily="34" charset="0"/>
                <a:ea typeface="宋体" panose="02010600030101010101" pitchFamily="2" charset="-122"/>
              </a:rPr>
              <a:t>CHMp cell lysate pull-down followed by Western Blot to validate BTF3 protein expression;</a:t>
            </a:r>
            <a:r>
              <a:rPr lang="en-US" altLang="zh-CN" sz="1050" b="1" kern="100" dirty="0">
                <a:latin typeface="Arial" panose="020B0604020202020204" pitchFamily="34" charset="0"/>
                <a:ea typeface="宋体" panose="02010600030101010101" pitchFamily="2" charset="-122"/>
              </a:rPr>
              <a:t> B: </a:t>
            </a:r>
            <a:r>
              <a:rPr lang="en-US" altLang="zh-CN" sz="1050" kern="100" dirty="0">
                <a:latin typeface="Arial" panose="020B0604020202020204" pitchFamily="34" charset="0"/>
                <a:ea typeface="宋体" panose="02010600030101010101" pitchFamily="2" charset="-122"/>
              </a:rPr>
              <a:t>CHMm cell lysate pull-down followed by Western Blot to validate BTF3 protein expression</a:t>
            </a:r>
            <a:endParaRPr lang="zh-CN" altLang="en-US" sz="1050" kern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18825264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>
            <a:extLst>
              <a:ext uri="{FF2B5EF4-FFF2-40B4-BE49-F238E27FC236}">
                <a16:creationId xmlns:a16="http://schemas.microsoft.com/office/drawing/2014/main" id="{A79C5F6A-9DAF-0D6A-A3F6-91EE02D67369}"/>
              </a:ext>
            </a:extLst>
          </p:cNvPr>
          <p:cNvPicPr>
            <a:picLocks noChangeAspect="1"/>
          </p:cNvPicPr>
          <p:nvPr/>
        </p:nvPicPr>
        <p:blipFill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9124" y="871803"/>
            <a:ext cx="5760732" cy="4319025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E27DF765-58EF-380D-3709-FCF3B7D5F2A0}"/>
              </a:ext>
            </a:extLst>
          </p:cNvPr>
          <p:cNvSpPr txBox="1"/>
          <p:nvPr/>
        </p:nvSpPr>
        <p:spPr>
          <a:xfrm>
            <a:off x="2407432" y="2777399"/>
            <a:ext cx="24063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2EEDCEE6-5414-F083-813A-665798B37E5E}"/>
              </a:ext>
            </a:extLst>
          </p:cNvPr>
          <p:cNvSpPr txBox="1"/>
          <p:nvPr/>
        </p:nvSpPr>
        <p:spPr>
          <a:xfrm>
            <a:off x="2407432" y="937977"/>
            <a:ext cx="24063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FFA6136-3652-DDBF-CC76-1A4DD6457534}"/>
              </a:ext>
            </a:extLst>
          </p:cNvPr>
          <p:cNvSpPr txBox="1"/>
          <p:nvPr/>
        </p:nvSpPr>
        <p:spPr>
          <a:xfrm>
            <a:off x="3140243" y="5047916"/>
            <a:ext cx="428324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Figure </a:t>
            </a:r>
            <a:r>
              <a:rPr lang="en-US" altLang="zh-CN" sz="1050" b="1" kern="100" dirty="0">
                <a:latin typeface="Arial" panose="020B0604020202020204" pitchFamily="34" charset="0"/>
                <a:ea typeface="宋体" panose="02010600030101010101" pitchFamily="2" charset="-122"/>
              </a:rPr>
              <a:t>S2</a:t>
            </a:r>
            <a:r>
              <a:rPr lang="en-US" altLang="zh-CN" sz="105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. </a:t>
            </a:r>
            <a:r>
              <a:rPr lang="en-US" altLang="zh-CN" sz="105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CETSA identifies BTF3 as a target of matrine action.</a:t>
            </a:r>
          </a:p>
          <a:p>
            <a:pPr algn="ctr"/>
            <a:r>
              <a:rPr lang="en-US" altLang="zh-CN" sz="105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A:</a:t>
            </a:r>
            <a:r>
              <a:rPr lang="en-US" altLang="zh-CN" sz="105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 CHMp CETSA identifies; </a:t>
            </a:r>
            <a:r>
              <a:rPr lang="en-US" altLang="zh-CN" sz="105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B:</a:t>
            </a:r>
            <a:r>
              <a:rPr lang="en-US" altLang="zh-CN" sz="105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 CHMm CETSA identifies</a:t>
            </a:r>
          </a:p>
        </p:txBody>
      </p:sp>
    </p:spTree>
    <p:extLst>
      <p:ext uri="{BB962C8B-B14F-4D97-AF65-F5344CB8AC3E}">
        <p14:creationId xmlns:p14="http://schemas.microsoft.com/office/powerpoint/2010/main" val="41898428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图片 28">
            <a:extLst>
              <a:ext uri="{FF2B5EF4-FFF2-40B4-BE49-F238E27FC236}">
                <a16:creationId xmlns:a16="http://schemas.microsoft.com/office/drawing/2014/main" id="{767BE052-6494-1CBA-F8F7-EA92CD43115A}"/>
              </a:ext>
            </a:extLst>
          </p:cNvPr>
          <p:cNvPicPr>
            <a:picLocks noChangeAspect="1"/>
          </p:cNvPicPr>
          <p:nvPr/>
        </p:nvPicPr>
        <p:blipFill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491179" y="447544"/>
            <a:ext cx="5760732" cy="4922530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F7AA802D-57C8-BB31-858D-245C2FF63AFA}"/>
              </a:ext>
            </a:extLst>
          </p:cNvPr>
          <p:cNvPicPr>
            <a:picLocks noChangeAspect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8332" y="455698"/>
            <a:ext cx="3941072" cy="5157226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E27DF765-58EF-380D-3709-FCF3B7D5F2A0}"/>
              </a:ext>
            </a:extLst>
          </p:cNvPr>
          <p:cNvSpPr txBox="1"/>
          <p:nvPr/>
        </p:nvSpPr>
        <p:spPr>
          <a:xfrm>
            <a:off x="373460" y="416576"/>
            <a:ext cx="24063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2EEDCEE6-5414-F083-813A-665798B37E5E}"/>
              </a:ext>
            </a:extLst>
          </p:cNvPr>
          <p:cNvSpPr txBox="1"/>
          <p:nvPr/>
        </p:nvSpPr>
        <p:spPr>
          <a:xfrm>
            <a:off x="373460" y="3081333"/>
            <a:ext cx="24063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6E80E304-1C3F-7D63-FDEF-422B5261ACA9}"/>
              </a:ext>
            </a:extLst>
          </p:cNvPr>
          <p:cNvSpPr txBox="1"/>
          <p:nvPr/>
        </p:nvSpPr>
        <p:spPr>
          <a:xfrm>
            <a:off x="4286049" y="447544"/>
            <a:ext cx="24063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041986AC-4197-3243-B4A1-2B29274FBA05}"/>
              </a:ext>
            </a:extLst>
          </p:cNvPr>
          <p:cNvSpPr txBox="1"/>
          <p:nvPr/>
        </p:nvSpPr>
        <p:spPr>
          <a:xfrm>
            <a:off x="4286049" y="3081333"/>
            <a:ext cx="24063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2D34B144-25F5-6EC0-67A9-482864D4C4F6}"/>
              </a:ext>
            </a:extLst>
          </p:cNvPr>
          <p:cNvSpPr txBox="1"/>
          <p:nvPr/>
        </p:nvSpPr>
        <p:spPr>
          <a:xfrm>
            <a:off x="8158487" y="478512"/>
            <a:ext cx="24063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B3E0C7D9-6B61-6DBD-61F2-8622455EBF94}"/>
              </a:ext>
            </a:extLst>
          </p:cNvPr>
          <p:cNvSpPr txBox="1"/>
          <p:nvPr/>
        </p:nvSpPr>
        <p:spPr>
          <a:xfrm>
            <a:off x="8177936" y="3034311"/>
            <a:ext cx="24063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0D5DD03E-C55E-7F20-1477-EA34F24CDEF8}"/>
              </a:ext>
            </a:extLst>
          </p:cNvPr>
          <p:cNvSpPr txBox="1"/>
          <p:nvPr/>
        </p:nvSpPr>
        <p:spPr>
          <a:xfrm>
            <a:off x="1591217" y="5590110"/>
            <a:ext cx="861958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 b="1" kern="10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Fig</a:t>
            </a:r>
            <a:r>
              <a:rPr lang="en-US" altLang="zh-CN" sz="1050" b="1" kern="100">
                <a:latin typeface="Arial" panose="020B0604020202020204" pitchFamily="34" charset="0"/>
                <a:ea typeface="宋体" panose="02010600030101010101" pitchFamily="2" charset="-122"/>
              </a:rPr>
              <a:t>ure S3</a:t>
            </a:r>
            <a:r>
              <a:rPr lang="en-US" altLang="zh-CN" sz="1050" b="1" kern="10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. </a:t>
            </a:r>
            <a:r>
              <a:rPr lang="en-US" altLang="zh-CN" sz="105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Effects of matrine on BTF3 protein in canine mammary tumor cells.</a:t>
            </a:r>
          </a:p>
          <a:p>
            <a:pPr algn="ctr"/>
            <a:r>
              <a:rPr lang="en-US" altLang="zh-CN" sz="105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A:</a:t>
            </a:r>
            <a:r>
              <a:rPr lang="en-US" altLang="zh-CN" sz="105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 Matrine action on CHMm cells for 24 h</a:t>
            </a:r>
            <a:r>
              <a:rPr lang="en-US" altLang="zh-CN" sz="105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; B:</a:t>
            </a:r>
            <a:r>
              <a:rPr lang="en-US" altLang="zh-CN" sz="105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 Matrine action on CHMp cells for 24 h; </a:t>
            </a:r>
            <a:r>
              <a:rPr lang="en-US" altLang="zh-CN" sz="105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C: </a:t>
            </a:r>
            <a:r>
              <a:rPr lang="en-US" altLang="zh-CN" sz="105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Matrine action on CHMm cells for 48 h; </a:t>
            </a:r>
            <a:r>
              <a:rPr lang="en-US" altLang="zh-CN" sz="105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D:</a:t>
            </a:r>
            <a:r>
              <a:rPr lang="en-US" altLang="zh-CN" sz="105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 Matrine action on CHMp cells for 48 h; </a:t>
            </a:r>
            <a:r>
              <a:rPr lang="en-US" altLang="zh-CN" sz="105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E:</a:t>
            </a:r>
            <a:r>
              <a:rPr lang="en-US" altLang="zh-CN" sz="105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 Matrine action on CHMm cells for 72 h; </a:t>
            </a:r>
            <a:r>
              <a:rPr lang="en-US" altLang="zh-CN" sz="105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F:</a:t>
            </a:r>
            <a:r>
              <a:rPr lang="en-US" altLang="zh-CN" sz="105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 Matrine action on CHMp cells for 72 h (different letters indicate significant differences, P &lt; 0.05).</a:t>
            </a: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77DE0095-8648-13A1-D20E-C8C97F9B78A9}"/>
              </a:ext>
            </a:extLst>
          </p:cNvPr>
          <p:cNvPicPr>
            <a:picLocks noChangeAspect="1"/>
          </p:cNvPicPr>
          <p:nvPr/>
        </p:nvPicPr>
        <p:blipFill>
          <a:blip r:embed="rId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2871" y="178549"/>
            <a:ext cx="5760732" cy="56662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09030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6</TotalTime>
  <Words>165</Words>
  <Application>Microsoft Office PowerPoint</Application>
  <PresentationFormat>Widescreen</PresentationFormat>
  <Paragraphs>1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等线</vt:lpstr>
      <vt:lpstr>等线 Light</vt:lpstr>
      <vt:lpstr>Arial</vt:lpstr>
      <vt:lpstr>Office 主题​​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F zj</dc:creator>
  <cp:lastModifiedBy>MDPI</cp:lastModifiedBy>
  <cp:revision>10</cp:revision>
  <dcterms:created xsi:type="dcterms:W3CDTF">2023-09-05T15:08:06Z</dcterms:created>
  <dcterms:modified xsi:type="dcterms:W3CDTF">2023-12-30T08:19:13Z</dcterms:modified>
</cp:coreProperties>
</file>